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314D36-A6C0-4CC3-B530-04A58231382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E3812D-892C-47CE-841B-F642EA0263D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438527-34DA-476B-9007-3549A6E9B64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8F5428-3B80-46F4-B977-855C1BCB0A8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36B0DA-5CA5-479E-81CE-69A8DBF43A5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D949D4-0287-455C-A99B-721C1FEE839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60594F-0462-41E5-B6DF-F8F0816E325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23185A-2F5A-4972-97FC-ECCC0D91656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B7505E-EBAD-4820-99DD-866CE660B99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37AD2E-63A7-4917-8215-065818D4A0B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EF85A0-1EE9-42DE-87CD-E25B7F5FE7F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E626E2-373C-40FC-A265-85E0D2E1E0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2B9ED8C-592D-43CD-9B78-AC3F760E8CDB}" type="datetime">
              <a:rPr b="0" lang="zh-CN" sz="1200" spc="-1" strike="noStrike">
                <a:solidFill>
                  <a:srgbClr val="898989"/>
                </a:solidFill>
                <a:latin typeface="Calibri"/>
              </a:rPr>
              <a:t>26/8/29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202129A-439A-4B77-9F70-738C75B620DA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直线连接符 1"/>
          <p:cNvSpPr/>
          <p:nvPr/>
        </p:nvSpPr>
        <p:spPr>
          <a:xfrm>
            <a:off x="303120" y="1084320"/>
            <a:ext cx="7201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直线连接符 23"/>
          <p:cNvSpPr/>
          <p:nvPr/>
        </p:nvSpPr>
        <p:spPr>
          <a:xfrm>
            <a:off x="303120" y="2149560"/>
            <a:ext cx="7201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直线连接符 24"/>
          <p:cNvSpPr/>
          <p:nvPr/>
        </p:nvSpPr>
        <p:spPr>
          <a:xfrm>
            <a:off x="303120" y="601560"/>
            <a:ext cx="7178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文本框 65"/>
          <p:cNvSpPr/>
          <p:nvPr/>
        </p:nvSpPr>
        <p:spPr>
          <a:xfrm>
            <a:off x="-104760" y="190440"/>
            <a:ext cx="7996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SUPPLEMENTARY TABLE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7 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Primer Information (Mutant Plasmid Construction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文本框 60"/>
          <p:cNvSpPr/>
          <p:nvPr/>
        </p:nvSpPr>
        <p:spPr>
          <a:xfrm>
            <a:off x="2347920" y="1273320"/>
            <a:ext cx="575928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5</a:t>
            </a:r>
            <a:r>
              <a:rPr b="0" lang="zh-CN" sz="1300" spc="-1" strike="noStrike">
                <a:solidFill>
                  <a:srgbClr val="000000"/>
                </a:solidFill>
                <a:latin typeface="Times New Roman"/>
              </a:rPr>
              <a:t>′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‑GTGGTGAGcAAAGTTACTGACACTGAAACTGAACGC‑3</a:t>
            </a:r>
            <a:r>
              <a:rPr b="0" lang="zh-CN" sz="1300" spc="-1" strike="noStrike">
                <a:solidFill>
                  <a:srgbClr val="000000"/>
                </a:solidFill>
                <a:latin typeface="Times New Roman"/>
              </a:rPr>
              <a:t>′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文本框 61"/>
          <p:cNvSpPr/>
          <p:nvPr/>
        </p:nvSpPr>
        <p:spPr>
          <a:xfrm>
            <a:off x="860400" y="1276200"/>
            <a:ext cx="36036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F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文本框 34"/>
          <p:cNvSpPr/>
          <p:nvPr/>
        </p:nvSpPr>
        <p:spPr>
          <a:xfrm>
            <a:off x="646200" y="663480"/>
            <a:ext cx="8254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direction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文本框 10"/>
          <p:cNvSpPr/>
          <p:nvPr/>
        </p:nvSpPr>
        <p:spPr>
          <a:xfrm>
            <a:off x="3962520" y="677880"/>
            <a:ext cx="11365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sequence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文本框 30"/>
          <p:cNvSpPr/>
          <p:nvPr/>
        </p:nvSpPr>
        <p:spPr>
          <a:xfrm>
            <a:off x="860400" y="1733400"/>
            <a:ext cx="36036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R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文本框 35"/>
          <p:cNvSpPr/>
          <p:nvPr/>
        </p:nvSpPr>
        <p:spPr>
          <a:xfrm>
            <a:off x="2347920" y="1666800"/>
            <a:ext cx="5759280" cy="382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 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5</a:t>
            </a:r>
            <a:r>
              <a:rPr b="0" lang="zh-CN" sz="1300" spc="-1" strike="noStrike">
                <a:solidFill>
                  <a:srgbClr val="000000"/>
                </a:solidFill>
                <a:latin typeface="Times New Roman"/>
              </a:rPr>
              <a:t>′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‑GTAACTTTgCTCACCACGGTGTCAGCACCTTT‑3</a:t>
            </a:r>
            <a:r>
              <a:rPr b="0" lang="zh-CN" sz="1300" spc="-1" strike="noStrike">
                <a:solidFill>
                  <a:srgbClr val="000000"/>
                </a:solidFill>
                <a:latin typeface="Times New Roman"/>
              </a:rPr>
              <a:t>′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文本框 9"/>
          <p:cNvSpPr/>
          <p:nvPr/>
        </p:nvSpPr>
        <p:spPr>
          <a:xfrm>
            <a:off x="216000" y="2149560"/>
            <a:ext cx="7995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宋体"/>
              </a:rPr>
              <a:t>Note: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宋体"/>
              </a:rPr>
              <a:t>lowercase letters denote the mutated bases: ‘c’ represents the T&gt;C substitution at cDNA position c.239+6, and ‘g’ is the complementary chang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3-08-09T12:44:00Z</dcterms:created>
  <dc:creator>ghl</dc:creator>
  <dc:description/>
  <dc:language>en-US</dc:language>
  <cp:lastModifiedBy>墨铁</cp:lastModifiedBy>
  <dcterms:modified xsi:type="dcterms:W3CDTF">2026-05-25T09:46:12Z</dcterms:modified>
  <cp:revision>57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4EF8A1A72F364BE3A5218373BDAA2C6E_13</vt:lpwstr>
  </property>
  <property fmtid="{D5CDD505-2E9C-101B-9397-08002B2CF9AE}" pid="3" name="KSOProductBuildVer">
    <vt:lpwstr>2052-12.1.0.26375</vt:lpwstr>
  </property>
</Properties>
</file>